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3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7" autoAdjust="0"/>
    <p:restoredTop sz="94660"/>
  </p:normalViewPr>
  <p:slideViewPr>
    <p:cSldViewPr snapToGrid="0">
      <p:cViewPr varScale="1">
        <p:scale>
          <a:sx n="60" d="100"/>
          <a:sy n="60" d="100"/>
        </p:scale>
        <p:origin x="52" y="2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1644BC-5A64-4F86-B2BF-F785C47173EE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FC1479-FE05-4081-BF97-22626AEBBE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9842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9" name="Google Shape;509;g2c703f76459_0_17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510" name="Google Shape;510;g2c703f76459_0_176:notes"/>
          <p:cNvSpPr>
            <a:spLocks noGrp="1" noRot="1" noChangeAspect="1"/>
          </p:cNvSpPr>
          <p:nvPr>
            <p:ph type="sldImg" idx="2"/>
          </p:nvPr>
        </p:nvSpPr>
        <p:spPr>
          <a:xfrm>
            <a:off x="857250" y="685800"/>
            <a:ext cx="51435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3974976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98C978-5F21-5E31-2FE2-91D1B7682A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EEE783-CA24-F70F-50E9-10320DF264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7D91BC-F1D2-7206-72D7-D5A6F006DC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A0840C-2372-EC6A-8B08-2EBD35065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CAE81-2296-98DD-47A7-46504440D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265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DB6955-0D84-6B88-983D-972938E57D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9A6B64-610B-41D4-FD5C-547C4C79BA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9D41C3-5D8F-45E2-2B72-4CD44C166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2680D-D1DA-0DD2-68B8-BAE5DE381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EEC248-390B-D604-FE30-ECBF4D92B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389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FD1A83-3CB4-8E9B-95CD-900A5B40CB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8F5FC2-D0CE-3032-BAA5-18FD3CCB59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9858C0-50BE-070D-33C7-45FE830E4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B3E2EB-5A5F-7378-4CE3-C85C5BAE5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9D41BA-AB44-8056-875B-64E5F30E2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14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1774B6-ACAB-9EB2-E21D-DB5AFAD467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6F65E6-EF46-54AD-C26D-14E2C70D62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6F610D-9BBF-D2D6-823B-351D4780B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A26225-C268-891B-615A-20171BCDC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C94FAB-DA95-0AF7-6FD9-79C53B6F1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671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600FDB-94CD-0775-1A59-3318C1AD3F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4EE598-F98F-BF9D-3B9B-BBF56F13AC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CEE4EE-7740-F9ED-2682-09630B5463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F82A6A-6D1C-44BE-EDC1-210A0CE66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0DD9CB-2CF8-44AB-036B-9571405D2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208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00C85D-0CCF-1101-A47D-73E2451987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937974-E871-2D88-E4C0-E16F0DC12B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3838EB-7DA6-8020-1EFC-E65358AA0F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BA515D-FC98-FAB9-D548-8667EF497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434560-244B-E424-DCBF-2C0804877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F15CC5-8D5C-EB74-FC6B-0D89B477D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199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85DBE1-78F4-46A7-F207-2E01E8DCF6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A8D44F-0C03-CD0F-FED5-53EA358D93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9CFFD6-75CE-4D0E-39E7-116187BE41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DDFCF4E-F3F5-9328-54DF-7E7121BC1E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5BA5AA-5A8C-5856-DC6C-9726A8D70E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9F07CF-13D8-DDA3-E059-251DFC8FF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ECAF045-741F-6229-1222-07FCBC4F0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4EE8793-869A-E1BA-389A-F8B8F8159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27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B43C6-CF85-F3A9-F1A8-F14AF03F73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F455665-9480-4948-5245-1C1D6C60C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63E06D8-406E-6518-C70C-8A243701E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B8D5DF-60A8-40AC-33F8-B6276197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220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2C545D-E5E4-83E4-56D4-D589C2B33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F16029-51B4-B148-DA92-5E73D7A14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34F9E8-9AEE-D259-73D5-69FE8AEEC2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271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BE17F4-8499-C3BE-4502-AC9ECD64CF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E33009-D55F-AEFD-1A93-4CDBEC78E2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C42F34-7580-E7E4-98B8-843443EDAB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B93474-ABB2-5621-A6E1-4DF3B55F1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2FE297-3401-9EFB-F4A5-62A1468D2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BC0E88-E636-7849-6456-4744EF41D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194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0757CD-AA90-A456-31A1-43A7901239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34F124-3172-427A-5D98-FAF7C6D4C8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7D8D01-8AAF-B89D-EE89-8F534F1E1E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79B6BA-2A2F-CF47-1285-6E1560717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784345-E4C0-00C5-F30A-3963B2A95B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122DCF-85DE-6540-CA1A-A9E9A3B07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4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37E889-3B4A-74D7-E102-81F19530C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AAAA86-40F5-6768-B7A0-0A433A6337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4DCD66-7D4D-5EB2-44F4-E4BEE78C4E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A101E4-38CA-4F15-B13C-15641EE14F59}" type="datetimeFigureOut">
              <a:rPr lang="en-US" smtClean="0"/>
              <a:t>8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31D9F8-9139-CDD4-97C4-CB55C0AB21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47335D-1D3D-082B-CE79-ED4B5605F8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F71F5F-699B-42C1-B420-CC73912DC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254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Google Shape;433;g2c703f76459_0_78">
            <a:extLst>
              <a:ext uri="{FF2B5EF4-FFF2-40B4-BE49-F238E27FC236}">
                <a16:creationId xmlns:a16="http://schemas.microsoft.com/office/drawing/2014/main" id="{28B21E70-8FB4-4DD9-B222-24A51625FEC5}"/>
              </a:ext>
            </a:extLst>
          </p:cNvPr>
          <p:cNvSpPr txBox="1"/>
          <p:nvPr/>
        </p:nvSpPr>
        <p:spPr>
          <a:xfrm>
            <a:off x="1771480" y="761976"/>
            <a:ext cx="7027875" cy="3462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69" tIns="34275" rIns="68569" bIns="34275" anchor="t" anchorCtr="0">
            <a:spAutoFit/>
          </a:bodyPr>
          <a:lstStyle/>
          <a:p>
            <a:pPr>
              <a:buClr>
                <a:srgbClr val="000000"/>
              </a:buClr>
              <a:buSzPts val="1600"/>
            </a:pPr>
            <a:r>
              <a:rPr lang="en-US" b="1" dirty="0">
                <a:solidFill>
                  <a:srgbClr val="382A2A"/>
                </a:solidFill>
                <a:latin typeface="Arial" panose="020B0604020202020204" pitchFamily="34" charset="0"/>
                <a:ea typeface="Century Gothic"/>
                <a:cs typeface="Arial" panose="020B0604020202020204" pitchFamily="34" charset="0"/>
                <a:sym typeface="Century Gothic"/>
              </a:rPr>
              <a:t>Suppl. Fig. 2</a:t>
            </a:r>
            <a:endParaRPr b="1" dirty="0">
              <a:solidFill>
                <a:srgbClr val="382A2A"/>
              </a:solidFill>
              <a:latin typeface="Arial" panose="020B0604020202020204" pitchFamily="34" charset="0"/>
              <a:ea typeface="Century Gothic"/>
              <a:cs typeface="Arial" panose="020B0604020202020204" pitchFamily="34" charset="0"/>
              <a:sym typeface="Century Gothic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857966F-A39B-4243-8195-B97939E06EED}"/>
              </a:ext>
            </a:extLst>
          </p:cNvPr>
          <p:cNvGrpSpPr/>
          <p:nvPr/>
        </p:nvGrpSpPr>
        <p:grpSpPr>
          <a:xfrm>
            <a:off x="1783635" y="1384552"/>
            <a:ext cx="3565981" cy="2238854"/>
            <a:chOff x="420156" y="1014795"/>
            <a:chExt cx="4754641" cy="2985138"/>
          </a:xfrm>
        </p:grpSpPr>
        <p:pic>
          <p:nvPicPr>
            <p:cNvPr id="4" name="Kép 3">
              <a:extLst>
                <a:ext uri="{FF2B5EF4-FFF2-40B4-BE49-F238E27FC236}">
                  <a16:creationId xmlns:a16="http://schemas.microsoft.com/office/drawing/2014/main" id="{E5C7DE0D-233F-B944-8093-BA40C3A022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330" r="14742" b="9999"/>
            <a:stretch/>
          </p:blipFill>
          <p:spPr>
            <a:xfrm>
              <a:off x="905933" y="1014795"/>
              <a:ext cx="4183266" cy="2507338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220A8F3-5389-4A4E-98AD-D295A264FB60}"/>
                </a:ext>
              </a:extLst>
            </p:cNvPr>
            <p:cNvSpPr txBox="1"/>
            <p:nvPr/>
          </p:nvSpPr>
          <p:spPr>
            <a:xfrm>
              <a:off x="626967" y="3692157"/>
              <a:ext cx="4547830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enescence core genes enrichment score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1E28704-8D3A-419A-9029-EAD3F2A17EDA}"/>
                </a:ext>
              </a:extLst>
            </p:cNvPr>
            <p:cNvSpPr txBox="1"/>
            <p:nvPr/>
          </p:nvSpPr>
          <p:spPr>
            <a:xfrm>
              <a:off x="1009283" y="3472025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5049B25-6146-4A17-9331-9BA4546A45EF}"/>
                </a:ext>
              </a:extLst>
            </p:cNvPr>
            <p:cNvSpPr txBox="1"/>
            <p:nvPr/>
          </p:nvSpPr>
          <p:spPr>
            <a:xfrm>
              <a:off x="1801468" y="3459326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CF200FA-FC68-485D-A2AB-7E9D6805378C}"/>
                </a:ext>
              </a:extLst>
            </p:cNvPr>
            <p:cNvSpPr txBox="1"/>
            <p:nvPr/>
          </p:nvSpPr>
          <p:spPr>
            <a:xfrm>
              <a:off x="2718567" y="3445936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EE9241F-FE3D-4E71-BF62-7E2E29C72042}"/>
                </a:ext>
              </a:extLst>
            </p:cNvPr>
            <p:cNvSpPr txBox="1"/>
            <p:nvPr/>
          </p:nvSpPr>
          <p:spPr>
            <a:xfrm>
              <a:off x="3592081" y="3459326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15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5EFD93F-35F0-4C46-8F65-9BEA57259DD1}"/>
                </a:ext>
              </a:extLst>
            </p:cNvPr>
            <p:cNvSpPr txBox="1"/>
            <p:nvPr/>
          </p:nvSpPr>
          <p:spPr>
            <a:xfrm>
              <a:off x="4465596" y="3459326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2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9663C00-9F02-4AAA-BF50-0A7138027BDA}"/>
                </a:ext>
              </a:extLst>
            </p:cNvPr>
            <p:cNvSpPr txBox="1"/>
            <p:nvPr/>
          </p:nvSpPr>
          <p:spPr>
            <a:xfrm>
              <a:off x="740436" y="3244447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A923852-0972-437A-80A3-BCF408B56E15}"/>
                </a:ext>
              </a:extLst>
            </p:cNvPr>
            <p:cNvSpPr txBox="1"/>
            <p:nvPr/>
          </p:nvSpPr>
          <p:spPr>
            <a:xfrm>
              <a:off x="726753" y="2787271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996F7F6-B8AF-4A6A-894A-2F6DD06A414A}"/>
                </a:ext>
              </a:extLst>
            </p:cNvPr>
            <p:cNvSpPr txBox="1"/>
            <p:nvPr/>
          </p:nvSpPr>
          <p:spPr>
            <a:xfrm>
              <a:off x="668125" y="2290140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7B58266-2032-4AE5-9646-886458AD1A34}"/>
                </a:ext>
              </a:extLst>
            </p:cNvPr>
            <p:cNvSpPr txBox="1"/>
            <p:nvPr/>
          </p:nvSpPr>
          <p:spPr>
            <a:xfrm>
              <a:off x="668124" y="1825991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1F4ECD1-3153-4088-8BBB-70C1E12E4D34}"/>
                </a:ext>
              </a:extLst>
            </p:cNvPr>
            <p:cNvSpPr txBox="1"/>
            <p:nvPr/>
          </p:nvSpPr>
          <p:spPr>
            <a:xfrm>
              <a:off x="668123" y="1340488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A18ADE0-CF10-44E2-8707-36B4442E6D71}"/>
                </a:ext>
              </a:extLst>
            </p:cNvPr>
            <p:cNvSpPr txBox="1"/>
            <p:nvPr/>
          </p:nvSpPr>
          <p:spPr>
            <a:xfrm rot="16200000">
              <a:off x="-334930" y="2181585"/>
              <a:ext cx="1817948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bability density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41E16EB6-7F72-498C-80C9-94B190904612}"/>
              </a:ext>
            </a:extLst>
          </p:cNvPr>
          <p:cNvGrpSpPr/>
          <p:nvPr/>
        </p:nvGrpSpPr>
        <p:grpSpPr>
          <a:xfrm>
            <a:off x="3576928" y="1525840"/>
            <a:ext cx="2704673" cy="452893"/>
            <a:chOff x="1482969" y="5124952"/>
            <a:chExt cx="3606230" cy="603857"/>
          </a:xfrm>
        </p:grpSpPr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2A281BB7-D6A5-48E6-86C7-27703997193B}"/>
                </a:ext>
              </a:extLst>
            </p:cNvPr>
            <p:cNvSpPr/>
            <p:nvPr/>
          </p:nvSpPr>
          <p:spPr>
            <a:xfrm>
              <a:off x="1482969" y="5179301"/>
              <a:ext cx="318499" cy="173627"/>
            </a:xfrm>
            <a:prstGeom prst="rect">
              <a:avLst/>
            </a:prstGeom>
            <a:solidFill>
              <a:srgbClr val="FFC9C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>
                <a:solidFill>
                  <a:srgbClr val="FFC9CA"/>
                </a:solidFill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78DCFD76-FA21-4D48-A4C9-00F31632DFCF}"/>
                </a:ext>
              </a:extLst>
            </p:cNvPr>
            <p:cNvSpPr/>
            <p:nvPr/>
          </p:nvSpPr>
          <p:spPr>
            <a:xfrm>
              <a:off x="1482969" y="5482125"/>
              <a:ext cx="318499" cy="168915"/>
            </a:xfrm>
            <a:prstGeom prst="rect">
              <a:avLst/>
            </a:prstGeom>
            <a:solidFill>
              <a:srgbClr val="ADF5F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50">
                <a:solidFill>
                  <a:srgbClr val="FFC9CA"/>
                </a:solidFill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45B9DF6-9BFE-40A3-B906-D38A50ABA32E}"/>
                </a:ext>
              </a:extLst>
            </p:cNvPr>
            <p:cNvSpPr txBox="1"/>
            <p:nvPr/>
          </p:nvSpPr>
          <p:spPr>
            <a:xfrm>
              <a:off x="1784820" y="5124952"/>
              <a:ext cx="3287731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lin2 pos ECs (aged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5EB59DE-C927-4EF1-8E85-2C139BBEEA22}"/>
                </a:ext>
              </a:extLst>
            </p:cNvPr>
            <p:cNvSpPr txBox="1"/>
            <p:nvPr/>
          </p:nvSpPr>
          <p:spPr>
            <a:xfrm>
              <a:off x="1801468" y="5421033"/>
              <a:ext cx="3287731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lin2 neg ECs (aged)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B93A522C-A5D6-45E3-BB00-3536A0400017}"/>
              </a:ext>
            </a:extLst>
          </p:cNvPr>
          <p:cNvGrpSpPr/>
          <p:nvPr/>
        </p:nvGrpSpPr>
        <p:grpSpPr>
          <a:xfrm>
            <a:off x="5570349" y="1384553"/>
            <a:ext cx="3754540" cy="2193130"/>
            <a:chOff x="5556145" y="955020"/>
            <a:chExt cx="5006053" cy="2924173"/>
          </a:xfrm>
        </p:grpSpPr>
        <p:pic>
          <p:nvPicPr>
            <p:cNvPr id="10" name="Kép 9">
              <a:extLst>
                <a:ext uri="{FF2B5EF4-FFF2-40B4-BE49-F238E27FC236}">
                  <a16:creationId xmlns:a16="http://schemas.microsoft.com/office/drawing/2014/main" id="{5EFDDEC9-31AF-BDED-BFBE-70D5D0AC8B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137" r="15561" b="9653"/>
            <a:stretch/>
          </p:blipFill>
          <p:spPr>
            <a:xfrm>
              <a:off x="5961809" y="955020"/>
              <a:ext cx="4150511" cy="2517006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477B998-53F3-4025-84FB-EF668D1968BB}"/>
                </a:ext>
              </a:extLst>
            </p:cNvPr>
            <p:cNvSpPr txBox="1"/>
            <p:nvPr/>
          </p:nvSpPr>
          <p:spPr>
            <a:xfrm>
              <a:off x="6074641" y="3399022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EAEB5E8-52C2-4B4E-95DB-EE597F358D7A}"/>
                </a:ext>
              </a:extLst>
            </p:cNvPr>
            <p:cNvSpPr txBox="1"/>
            <p:nvPr/>
          </p:nvSpPr>
          <p:spPr>
            <a:xfrm>
              <a:off x="7186198" y="3399021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22BAE07-1B7F-4ACC-8AAF-5E01566069A9}"/>
                </a:ext>
              </a:extLst>
            </p:cNvPr>
            <p:cNvSpPr txBox="1"/>
            <p:nvPr/>
          </p:nvSpPr>
          <p:spPr>
            <a:xfrm>
              <a:off x="8348442" y="3399020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7C37F91-FB23-4FEC-BC5D-89265EA345F1}"/>
                </a:ext>
              </a:extLst>
            </p:cNvPr>
            <p:cNvSpPr txBox="1"/>
            <p:nvPr/>
          </p:nvSpPr>
          <p:spPr>
            <a:xfrm>
              <a:off x="9510686" y="3399020"/>
              <a:ext cx="47821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1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95454AD-311B-40B4-A7F9-D5728C2B5CFA}"/>
                </a:ext>
              </a:extLst>
            </p:cNvPr>
            <p:cNvSpPr txBox="1"/>
            <p:nvPr/>
          </p:nvSpPr>
          <p:spPr>
            <a:xfrm>
              <a:off x="6014367" y="3571417"/>
              <a:ext cx="4547831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ASP genes enrichment score 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EC57AE8-5101-4813-9848-8CF5FB8F491B}"/>
                </a:ext>
              </a:extLst>
            </p:cNvPr>
            <p:cNvSpPr txBox="1"/>
            <p:nvPr/>
          </p:nvSpPr>
          <p:spPr>
            <a:xfrm>
              <a:off x="5784846" y="3182778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AEB03A7-19F0-46AE-A153-9C75D6E69DDE}"/>
                </a:ext>
              </a:extLst>
            </p:cNvPr>
            <p:cNvSpPr txBox="1"/>
            <p:nvPr/>
          </p:nvSpPr>
          <p:spPr>
            <a:xfrm>
              <a:off x="5785857" y="2536361"/>
              <a:ext cx="1884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4F6547A-F19E-4174-A901-EEC0B70B6FB6}"/>
                </a:ext>
              </a:extLst>
            </p:cNvPr>
            <p:cNvSpPr txBox="1"/>
            <p:nvPr/>
          </p:nvSpPr>
          <p:spPr>
            <a:xfrm>
              <a:off x="5740035" y="1856179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591CF47-BDA1-420D-A6DF-208AB7DC5AAE}"/>
                </a:ext>
              </a:extLst>
            </p:cNvPr>
            <p:cNvSpPr txBox="1"/>
            <p:nvPr/>
          </p:nvSpPr>
          <p:spPr>
            <a:xfrm>
              <a:off x="5735259" y="1185729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EF77B9C-1DE2-4C87-BC7B-FDD9F61EB774}"/>
                </a:ext>
              </a:extLst>
            </p:cNvPr>
            <p:cNvSpPr txBox="1"/>
            <p:nvPr/>
          </p:nvSpPr>
          <p:spPr>
            <a:xfrm rot="16200000">
              <a:off x="4801059" y="2136252"/>
              <a:ext cx="1817948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bability density</a:t>
              </a: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5B2E5FDC-323E-4BB7-A991-8C8E97337F97}"/>
              </a:ext>
            </a:extLst>
          </p:cNvPr>
          <p:cNvGrpSpPr/>
          <p:nvPr/>
        </p:nvGrpSpPr>
        <p:grpSpPr>
          <a:xfrm>
            <a:off x="1783636" y="3716374"/>
            <a:ext cx="3597421" cy="2223542"/>
            <a:chOff x="5556146" y="3920797"/>
            <a:chExt cx="4796562" cy="2964723"/>
          </a:xfrm>
        </p:grpSpPr>
        <p:pic>
          <p:nvPicPr>
            <p:cNvPr id="11" name="Kép 10">
              <a:extLst>
                <a:ext uri="{FF2B5EF4-FFF2-40B4-BE49-F238E27FC236}">
                  <a16:creationId xmlns:a16="http://schemas.microsoft.com/office/drawing/2014/main" id="{955D50FB-29AC-E17A-B54E-134B602D2A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756" r="15560" b="9652"/>
            <a:stretch/>
          </p:blipFill>
          <p:spPr>
            <a:xfrm>
              <a:off x="6072405" y="3920797"/>
              <a:ext cx="4118103" cy="2517007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7769646-5DCA-4154-8C12-F642C97B29B2}"/>
                </a:ext>
              </a:extLst>
            </p:cNvPr>
            <p:cNvSpPr txBox="1"/>
            <p:nvPr/>
          </p:nvSpPr>
          <p:spPr>
            <a:xfrm>
              <a:off x="6146450" y="6355451"/>
              <a:ext cx="1884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3501021-8F5F-4C53-A56E-1A4D6E615309}"/>
                </a:ext>
              </a:extLst>
            </p:cNvPr>
            <p:cNvSpPr txBox="1"/>
            <p:nvPr/>
          </p:nvSpPr>
          <p:spPr>
            <a:xfrm>
              <a:off x="7054806" y="6355449"/>
              <a:ext cx="47821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3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116CD00-DE71-4D89-8493-CC81B5D926DF}"/>
                </a:ext>
              </a:extLst>
            </p:cNvPr>
            <p:cNvSpPr txBox="1"/>
            <p:nvPr/>
          </p:nvSpPr>
          <p:spPr>
            <a:xfrm>
              <a:off x="8013851" y="6355449"/>
              <a:ext cx="47821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6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0F63F76-955C-4C48-910E-9D47B4B624FC}"/>
                </a:ext>
              </a:extLst>
            </p:cNvPr>
            <p:cNvSpPr txBox="1"/>
            <p:nvPr/>
          </p:nvSpPr>
          <p:spPr>
            <a:xfrm>
              <a:off x="8982535" y="6355449"/>
              <a:ext cx="478217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.09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56C4D28-830F-408C-810C-C0A4BEAE5F8D}"/>
                </a:ext>
              </a:extLst>
            </p:cNvPr>
            <p:cNvSpPr txBox="1"/>
            <p:nvPr/>
          </p:nvSpPr>
          <p:spPr>
            <a:xfrm>
              <a:off x="5876425" y="6149167"/>
              <a:ext cx="1884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E724961-356A-467C-B950-B7A540F6919A}"/>
                </a:ext>
              </a:extLst>
            </p:cNvPr>
            <p:cNvSpPr txBox="1"/>
            <p:nvPr/>
          </p:nvSpPr>
          <p:spPr>
            <a:xfrm>
              <a:off x="5862742" y="5691991"/>
              <a:ext cx="1884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8435134-51A3-4804-893F-41397717BA19}"/>
                </a:ext>
              </a:extLst>
            </p:cNvPr>
            <p:cNvSpPr txBox="1"/>
            <p:nvPr/>
          </p:nvSpPr>
          <p:spPr>
            <a:xfrm>
              <a:off x="5823709" y="5214362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C653162-92ED-4060-A0CA-EAAE651EB49E}"/>
                </a:ext>
              </a:extLst>
            </p:cNvPr>
            <p:cNvSpPr txBox="1"/>
            <p:nvPr/>
          </p:nvSpPr>
          <p:spPr>
            <a:xfrm>
              <a:off x="5823708" y="4768793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98219FDE-FA52-480A-957B-36BB39AD6A4E}"/>
                </a:ext>
              </a:extLst>
            </p:cNvPr>
            <p:cNvSpPr txBox="1"/>
            <p:nvPr/>
          </p:nvSpPr>
          <p:spPr>
            <a:xfrm>
              <a:off x="5823706" y="4291165"/>
              <a:ext cx="35596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ED8940E-A56E-447E-89D0-0E104C2ED804}"/>
                </a:ext>
              </a:extLst>
            </p:cNvPr>
            <p:cNvSpPr txBox="1"/>
            <p:nvPr/>
          </p:nvSpPr>
          <p:spPr>
            <a:xfrm rot="16200000">
              <a:off x="4801060" y="5086304"/>
              <a:ext cx="1817948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robability density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C15050D-5846-4529-8087-65AE74ED6807}"/>
                </a:ext>
              </a:extLst>
            </p:cNvPr>
            <p:cNvSpPr txBox="1"/>
            <p:nvPr/>
          </p:nvSpPr>
          <p:spPr>
            <a:xfrm>
              <a:off x="5804877" y="6577744"/>
              <a:ext cx="4547831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euroinflammation genes enrichment score </a:t>
              </a: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4F95C05A-F605-4D27-A5DE-D8C8E45500A9}"/>
              </a:ext>
            </a:extLst>
          </p:cNvPr>
          <p:cNvSpPr txBox="1"/>
          <p:nvPr/>
        </p:nvSpPr>
        <p:spPr>
          <a:xfrm>
            <a:off x="1640647" y="1254484"/>
            <a:ext cx="289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70BFA87-7DCE-4337-AC09-8C3BE5C1A865}"/>
              </a:ext>
            </a:extLst>
          </p:cNvPr>
          <p:cNvSpPr txBox="1"/>
          <p:nvPr/>
        </p:nvSpPr>
        <p:spPr>
          <a:xfrm>
            <a:off x="5475799" y="1252582"/>
            <a:ext cx="289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9100532-27AA-4F8E-903B-477232BFFA6E}"/>
              </a:ext>
            </a:extLst>
          </p:cNvPr>
          <p:cNvSpPr txBox="1"/>
          <p:nvPr/>
        </p:nvSpPr>
        <p:spPr>
          <a:xfrm>
            <a:off x="1629731" y="3546448"/>
            <a:ext cx="28942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072701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Widescreen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huvana Plakkot</dc:creator>
  <cp:lastModifiedBy>Bhuvana Plakkot</cp:lastModifiedBy>
  <cp:revision>1</cp:revision>
  <dcterms:created xsi:type="dcterms:W3CDTF">2025-08-22T22:02:49Z</dcterms:created>
  <dcterms:modified xsi:type="dcterms:W3CDTF">2025-08-22T22:03:10Z</dcterms:modified>
</cp:coreProperties>
</file>